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2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00"/>
    <a:srgbClr val="003399"/>
    <a:srgbClr val="DDDDDD"/>
    <a:srgbClr val="FE5048"/>
    <a:srgbClr val="66FFFF"/>
    <a:srgbClr val="FFFF00"/>
    <a:srgbClr val="00939E"/>
    <a:srgbClr val="FAC090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30" autoAdjust="0"/>
    <p:restoredTop sz="97865" autoAdjust="0"/>
  </p:normalViewPr>
  <p:slideViewPr>
    <p:cSldViewPr snapToGrid="0">
      <p:cViewPr>
        <p:scale>
          <a:sx n="100" d="100"/>
          <a:sy n="100" d="100"/>
        </p:scale>
        <p:origin x="1092" y="-424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0EA93D-047F-4673-9902-8349CA236320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E7FF01-A525-4F24-A6F9-E15228FD40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5438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248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91895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46920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14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0931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937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928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1507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160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658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1397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8077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3" name="Group 212">
            <a:extLst>
              <a:ext uri="{FF2B5EF4-FFF2-40B4-BE49-F238E27FC236}">
                <a16:creationId xmlns:a16="http://schemas.microsoft.com/office/drawing/2014/main" id="{7C17FBD2-0B3B-47E9-8905-20C0EBA4D841}"/>
              </a:ext>
            </a:extLst>
          </p:cNvPr>
          <p:cNvGrpSpPr/>
          <p:nvPr/>
        </p:nvGrpSpPr>
        <p:grpSpPr>
          <a:xfrm>
            <a:off x="97979" y="246316"/>
            <a:ext cx="6734894" cy="6240326"/>
            <a:chOff x="97979" y="246316"/>
            <a:chExt cx="6734894" cy="6240326"/>
          </a:xfrm>
        </p:grpSpPr>
        <p:grpSp>
          <p:nvGrpSpPr>
            <p:cNvPr id="214" name="Group 213">
              <a:extLst>
                <a:ext uri="{FF2B5EF4-FFF2-40B4-BE49-F238E27FC236}">
                  <a16:creationId xmlns:a16="http://schemas.microsoft.com/office/drawing/2014/main" id="{8F18556C-5046-42EA-9265-8E2F0B917058}"/>
                </a:ext>
              </a:extLst>
            </p:cNvPr>
            <p:cNvGrpSpPr/>
            <p:nvPr/>
          </p:nvGrpSpPr>
          <p:grpSpPr>
            <a:xfrm>
              <a:off x="113414" y="2425758"/>
              <a:ext cx="6719459" cy="4060884"/>
              <a:chOff x="113414" y="2425758"/>
              <a:chExt cx="6719459" cy="4060884"/>
            </a:xfrm>
          </p:grpSpPr>
          <p:grpSp>
            <p:nvGrpSpPr>
              <p:cNvPr id="237" name="Group 236">
                <a:extLst>
                  <a:ext uri="{FF2B5EF4-FFF2-40B4-BE49-F238E27FC236}">
                    <a16:creationId xmlns:a16="http://schemas.microsoft.com/office/drawing/2014/main" id="{46214257-11F1-46F9-ABE4-E3FFFA8D0A7D}"/>
                  </a:ext>
                </a:extLst>
              </p:cNvPr>
              <p:cNvGrpSpPr/>
              <p:nvPr/>
            </p:nvGrpSpPr>
            <p:grpSpPr>
              <a:xfrm>
                <a:off x="113414" y="2425758"/>
                <a:ext cx="6658069" cy="2033593"/>
                <a:chOff x="113414" y="2425758"/>
                <a:chExt cx="6658069" cy="2033593"/>
              </a:xfrm>
            </p:grpSpPr>
            <p:pic>
              <p:nvPicPr>
                <p:cNvPr id="260" name="Content Placeholder 3">
                  <a:extLst>
                    <a:ext uri="{FF2B5EF4-FFF2-40B4-BE49-F238E27FC236}">
                      <a16:creationId xmlns:a16="http://schemas.microsoft.com/office/drawing/2014/main" id="{14AB274E-EC70-4BF1-BD8F-D17338478EF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5783" t="16855" r="5783" b="5947"/>
                <a:stretch/>
              </p:blipFill>
              <p:spPr>
                <a:xfrm>
                  <a:off x="323380" y="2627358"/>
                  <a:ext cx="1990241" cy="1737360"/>
                </a:xfrm>
                <a:prstGeom prst="rect">
                  <a:avLst/>
                </a:prstGeom>
              </p:spPr>
            </p:pic>
            <p:pic>
              <p:nvPicPr>
                <p:cNvPr id="261" name="Content Placeholder 3">
                  <a:extLst>
                    <a:ext uri="{FF2B5EF4-FFF2-40B4-BE49-F238E27FC236}">
                      <a16:creationId xmlns:a16="http://schemas.microsoft.com/office/drawing/2014/main" id="{63443F42-D2D2-4F14-B0D9-B8786AEAA14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5442" t="16417" r="7972" b="5558"/>
                <a:stretch/>
              </p:blipFill>
              <p:spPr>
                <a:xfrm>
                  <a:off x="2539841" y="2614974"/>
                  <a:ext cx="1927997" cy="1737360"/>
                </a:xfrm>
                <a:prstGeom prst="rect">
                  <a:avLst/>
                </a:prstGeom>
              </p:spPr>
            </p:pic>
            <p:pic>
              <p:nvPicPr>
                <p:cNvPr id="262" name="Content Placeholder 3">
                  <a:extLst>
                    <a:ext uri="{FF2B5EF4-FFF2-40B4-BE49-F238E27FC236}">
                      <a16:creationId xmlns:a16="http://schemas.microsoft.com/office/drawing/2014/main" id="{BC6287AC-C357-4E17-9DE7-9574A03B597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5442" t="16418" r="5442" b="5752"/>
                <a:stretch/>
              </p:blipFill>
              <p:spPr>
                <a:xfrm>
                  <a:off x="4717323" y="2563138"/>
                  <a:ext cx="1989273" cy="1737360"/>
                </a:xfrm>
                <a:prstGeom prst="rect">
                  <a:avLst/>
                </a:prstGeom>
              </p:spPr>
            </p:pic>
            <p:grpSp>
              <p:nvGrpSpPr>
                <p:cNvPr id="263" name="Group 262">
                  <a:extLst>
                    <a:ext uri="{FF2B5EF4-FFF2-40B4-BE49-F238E27FC236}">
                      <a16:creationId xmlns:a16="http://schemas.microsoft.com/office/drawing/2014/main" id="{256928F1-E093-4006-9CAA-A506BF2A3554}"/>
                    </a:ext>
                  </a:extLst>
                </p:cNvPr>
                <p:cNvGrpSpPr/>
                <p:nvPr/>
              </p:nvGrpSpPr>
              <p:grpSpPr>
                <a:xfrm>
                  <a:off x="113414" y="2425758"/>
                  <a:ext cx="6658069" cy="2033593"/>
                  <a:chOff x="113414" y="2425758"/>
                  <a:chExt cx="6658069" cy="2033593"/>
                </a:xfrm>
              </p:grpSpPr>
              <p:grpSp>
                <p:nvGrpSpPr>
                  <p:cNvPr id="264" name="Group 263">
                    <a:extLst>
                      <a:ext uri="{FF2B5EF4-FFF2-40B4-BE49-F238E27FC236}">
                        <a16:creationId xmlns:a16="http://schemas.microsoft.com/office/drawing/2014/main" id="{8AA0718F-88DE-4A0B-A942-A014604D4984}"/>
                      </a:ext>
                    </a:extLst>
                  </p:cNvPr>
                  <p:cNvGrpSpPr/>
                  <p:nvPr/>
                </p:nvGrpSpPr>
                <p:grpSpPr>
                  <a:xfrm>
                    <a:off x="334843" y="2425758"/>
                    <a:ext cx="4881256" cy="253916"/>
                    <a:chOff x="1884133" y="116423"/>
                    <a:chExt cx="4881256" cy="253916"/>
                  </a:xfrm>
                </p:grpSpPr>
                <p:sp>
                  <p:nvSpPr>
                    <p:cNvPr id="278" name="TextBox 277">
                      <a:extLst>
                        <a:ext uri="{FF2B5EF4-FFF2-40B4-BE49-F238E27FC236}">
                          <a16:creationId xmlns:a16="http://schemas.microsoft.com/office/drawing/2014/main" id="{12C6BBA6-1EC2-4F80-85BF-A2DB90DBFD3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136635" y="116423"/>
                      <a:ext cx="352836" cy="2539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p:txBody>
                </p:sp>
                <p:sp>
                  <p:nvSpPr>
                    <p:cNvPr id="279" name="TextBox 278">
                      <a:extLst>
                        <a:ext uri="{FF2B5EF4-FFF2-40B4-BE49-F238E27FC236}">
                          <a16:creationId xmlns:a16="http://schemas.microsoft.com/office/drawing/2014/main" id="{38E8EF67-93D2-484C-BF67-2095B88055E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84133" y="116423"/>
                      <a:ext cx="400142" cy="2539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p:txBody>
                </p:sp>
                <p:sp>
                  <p:nvSpPr>
                    <p:cNvPr id="280" name="TextBox 279">
                      <a:extLst>
                        <a:ext uri="{FF2B5EF4-FFF2-40B4-BE49-F238E27FC236}">
                          <a16:creationId xmlns:a16="http://schemas.microsoft.com/office/drawing/2014/main" id="{7D3D5D1E-159E-47EC-BF73-8A858C27E24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341830" y="116423"/>
                      <a:ext cx="423559" cy="2539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p:txBody>
                </p:sp>
              </p:grpSp>
              <p:grpSp>
                <p:nvGrpSpPr>
                  <p:cNvPr id="265" name="Group 264">
                    <a:extLst>
                      <a:ext uri="{FF2B5EF4-FFF2-40B4-BE49-F238E27FC236}">
                        <a16:creationId xmlns:a16="http://schemas.microsoft.com/office/drawing/2014/main" id="{531CC649-E106-493B-9B1B-40ACCCB1DE90}"/>
                      </a:ext>
                    </a:extLst>
                  </p:cNvPr>
                  <p:cNvGrpSpPr/>
                  <p:nvPr/>
                </p:nvGrpSpPr>
                <p:grpSpPr>
                  <a:xfrm>
                    <a:off x="113414" y="2553541"/>
                    <a:ext cx="6658069" cy="1905810"/>
                    <a:chOff x="113414" y="2553541"/>
                    <a:chExt cx="6658069" cy="1905810"/>
                  </a:xfrm>
                </p:grpSpPr>
                <p:grpSp>
                  <p:nvGrpSpPr>
                    <p:cNvPr id="266" name="Group 265">
                      <a:extLst>
                        <a:ext uri="{FF2B5EF4-FFF2-40B4-BE49-F238E27FC236}">
                          <a16:creationId xmlns:a16="http://schemas.microsoft.com/office/drawing/2014/main" id="{DDF27B80-F0CB-47FE-B008-28CC7CB64CE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13414" y="2611924"/>
                      <a:ext cx="2217822" cy="1843693"/>
                      <a:chOff x="109021" y="129620"/>
                      <a:chExt cx="2217822" cy="1843693"/>
                    </a:xfrm>
                  </p:grpSpPr>
                  <p:sp>
                    <p:nvSpPr>
                      <p:cNvPr id="275" name="TextBox 274">
                        <a:extLst>
                          <a:ext uri="{FF2B5EF4-FFF2-40B4-BE49-F238E27FC236}">
                            <a16:creationId xmlns:a16="http://schemas.microsoft.com/office/drawing/2014/main" id="{735094FB-A61D-4D6E-A613-CB1F42FD6F09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800000">
                        <a:off x="290719" y="1726381"/>
                        <a:ext cx="950291" cy="2469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 (mg kg</a:t>
                        </a:r>
                        <a:r>
                          <a:rPr lang="en-US" sz="1000" baseline="300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ea typeface="Times New Roman" panose="02020603050405020304" pitchFamily="18" charset="0"/>
                            <a:cs typeface="Arial" panose="020B0604020202020204" pitchFamily="34" charset="0"/>
                          </a:rPr>
                          <a:t>‒1</a:t>
                        </a:r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)</a:t>
                        </a:r>
                        <a:endParaRPr 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76" name="TextBox 275">
                        <a:extLst>
                          <a:ext uri="{FF2B5EF4-FFF2-40B4-BE49-F238E27FC236}">
                            <a16:creationId xmlns:a16="http://schemas.microsoft.com/office/drawing/2014/main" id="{D47F29C2-E713-497A-9766-82D72668FEB7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920000">
                        <a:off x="1484396" y="1673099"/>
                        <a:ext cx="842447" cy="2469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N (mg kg</a:t>
                        </a:r>
                        <a:r>
                          <a:rPr lang="en-US" sz="1000" baseline="300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ea typeface="Times New Roman" panose="02020603050405020304" pitchFamily="18" charset="0"/>
                            <a:cs typeface="Arial" panose="020B0604020202020204" pitchFamily="34" charset="0"/>
                          </a:rPr>
                          <a:t>‒1</a:t>
                        </a:r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)</a:t>
                        </a:r>
                        <a:endParaRPr 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77" name="TextBox 276">
                        <a:extLst>
                          <a:ext uri="{FF2B5EF4-FFF2-40B4-BE49-F238E27FC236}">
                            <a16:creationId xmlns:a16="http://schemas.microsoft.com/office/drawing/2014/main" id="{4D8F2DBF-9917-4E42-A833-1193894843DC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080000">
                        <a:off x="-528111" y="766752"/>
                        <a:ext cx="1520486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tem diameter (mm)</a:t>
                        </a:r>
                        <a:endParaRPr 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267" name="Group 266">
                      <a:extLst>
                        <a:ext uri="{FF2B5EF4-FFF2-40B4-BE49-F238E27FC236}">
                          <a16:creationId xmlns:a16="http://schemas.microsoft.com/office/drawing/2014/main" id="{30AB60E2-B0E7-404D-9F6D-124BC742166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335391" y="2553541"/>
                      <a:ext cx="2261779" cy="1905810"/>
                      <a:chOff x="2144118" y="48770"/>
                      <a:chExt cx="2261779" cy="1905810"/>
                    </a:xfrm>
                  </p:grpSpPr>
                  <p:sp>
                    <p:nvSpPr>
                      <p:cNvPr id="272" name="TextBox 271">
                        <a:extLst>
                          <a:ext uri="{FF2B5EF4-FFF2-40B4-BE49-F238E27FC236}">
                            <a16:creationId xmlns:a16="http://schemas.microsoft.com/office/drawing/2014/main" id="{9ABA8996-5F53-451A-B4FE-8974A23141C3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080000">
                        <a:off x="1506431" y="686457"/>
                        <a:ext cx="1521596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oot length (cm)</a:t>
                        </a:r>
                        <a:endParaRPr 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73" name="TextBox 272">
                        <a:extLst>
                          <a:ext uri="{FF2B5EF4-FFF2-40B4-BE49-F238E27FC236}">
                            <a16:creationId xmlns:a16="http://schemas.microsoft.com/office/drawing/2014/main" id="{55BFE338-6868-4357-A5AC-D4DA81BEA2DE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">
                        <a:off x="2395834" y="1708359"/>
                        <a:ext cx="920946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 (mg kg</a:t>
                        </a:r>
                        <a:r>
                          <a:rPr lang="en-US" sz="1000" baseline="300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ea typeface="Times New Roman" panose="02020603050405020304" pitchFamily="18" charset="0"/>
                            <a:cs typeface="Arial" panose="020B0604020202020204" pitchFamily="34" charset="0"/>
                          </a:rPr>
                          <a:t>‒1</a:t>
                        </a:r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)</a:t>
                        </a:r>
                        <a:endParaRPr 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74" name="TextBox 273">
                        <a:extLst>
                          <a:ext uri="{FF2B5EF4-FFF2-40B4-BE49-F238E27FC236}">
                            <a16:creationId xmlns:a16="http://schemas.microsoft.com/office/drawing/2014/main" id="{CED01674-E641-46C8-94C0-DA96F44C9A20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920000">
                        <a:off x="3563450" y="1643692"/>
                        <a:ext cx="842447" cy="2469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W (% FC)</a:t>
                        </a:r>
                        <a:endParaRPr 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268" name="Group 267">
                      <a:extLst>
                        <a:ext uri="{FF2B5EF4-FFF2-40B4-BE49-F238E27FC236}">
                          <a16:creationId xmlns:a16="http://schemas.microsoft.com/office/drawing/2014/main" id="{FA6FC72D-1647-4990-9316-5FA9CEDFD1A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463459" y="2634045"/>
                      <a:ext cx="2308024" cy="1775522"/>
                      <a:chOff x="4347290" y="247671"/>
                      <a:chExt cx="2308024" cy="1775522"/>
                    </a:xfrm>
                  </p:grpSpPr>
                  <p:sp>
                    <p:nvSpPr>
                      <p:cNvPr id="269" name="TextBox 268">
                        <a:extLst>
                          <a:ext uri="{FF2B5EF4-FFF2-40B4-BE49-F238E27FC236}">
                            <a16:creationId xmlns:a16="http://schemas.microsoft.com/office/drawing/2014/main" id="{0CB36074-2906-4FD7-A6C5-467B0084E278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">
                        <a:off x="4567235" y="1776972"/>
                        <a:ext cx="920946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 (mg kg</a:t>
                        </a:r>
                        <a:r>
                          <a:rPr lang="en-US" sz="1000" baseline="300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ea typeface="Times New Roman" panose="02020603050405020304" pitchFamily="18" charset="0"/>
                            <a:cs typeface="Arial" panose="020B0604020202020204" pitchFamily="34" charset="0"/>
                          </a:rPr>
                          <a:t>‒1</a:t>
                        </a:r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)</a:t>
                        </a:r>
                        <a:endParaRPr 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70" name="TextBox 269">
                        <a:extLst>
                          <a:ext uri="{FF2B5EF4-FFF2-40B4-BE49-F238E27FC236}">
                            <a16:creationId xmlns:a16="http://schemas.microsoft.com/office/drawing/2014/main" id="{27A61DD9-D87F-4B67-AB93-93A1123ED113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080000">
                        <a:off x="3825835" y="769126"/>
                        <a:ext cx="1289131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oot length (cm)</a:t>
                        </a:r>
                        <a:endParaRPr 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71" name="TextBox 270">
                        <a:extLst>
                          <a:ext uri="{FF2B5EF4-FFF2-40B4-BE49-F238E27FC236}">
                            <a16:creationId xmlns:a16="http://schemas.microsoft.com/office/drawing/2014/main" id="{2DD3C831-4D3A-4912-BE37-6879EC7626C9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800000">
                        <a:off x="5705023" y="1746827"/>
                        <a:ext cx="950291" cy="2469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N (mg kg</a:t>
                        </a:r>
                        <a:r>
                          <a:rPr lang="en-US" sz="1000" baseline="300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ea typeface="Times New Roman" panose="02020603050405020304" pitchFamily="18" charset="0"/>
                            <a:cs typeface="Arial" panose="020B0604020202020204" pitchFamily="34" charset="0"/>
                          </a:rPr>
                          <a:t>‒1</a:t>
                        </a:r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)</a:t>
                        </a:r>
                        <a:endParaRPr 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</p:grpSp>
            </p:grpSp>
          </p:grpSp>
          <p:grpSp>
            <p:nvGrpSpPr>
              <p:cNvPr id="238" name="Group 237">
                <a:extLst>
                  <a:ext uri="{FF2B5EF4-FFF2-40B4-BE49-F238E27FC236}">
                    <a16:creationId xmlns:a16="http://schemas.microsoft.com/office/drawing/2014/main" id="{BD31ABAC-377B-4718-8EAD-6ADAB33596F8}"/>
                  </a:ext>
                </a:extLst>
              </p:cNvPr>
              <p:cNvGrpSpPr/>
              <p:nvPr/>
            </p:nvGrpSpPr>
            <p:grpSpPr>
              <a:xfrm>
                <a:off x="174804" y="4453049"/>
                <a:ext cx="6658069" cy="2033593"/>
                <a:chOff x="174804" y="4453049"/>
                <a:chExt cx="6658069" cy="2033593"/>
              </a:xfrm>
            </p:grpSpPr>
            <p:pic>
              <p:nvPicPr>
                <p:cNvPr id="239" name="Content Placeholder 3">
                  <a:extLst>
                    <a:ext uri="{FF2B5EF4-FFF2-40B4-BE49-F238E27FC236}">
                      <a16:creationId xmlns:a16="http://schemas.microsoft.com/office/drawing/2014/main" id="{501F9E62-7DB1-4BBB-A6A2-C5CDBA9198C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5442" t="16612" r="5638" b="5947"/>
                <a:stretch/>
              </p:blipFill>
              <p:spPr>
                <a:xfrm>
                  <a:off x="431137" y="4676649"/>
                  <a:ext cx="1994912" cy="1737360"/>
                </a:xfrm>
                <a:prstGeom prst="rect">
                  <a:avLst/>
                </a:prstGeom>
              </p:spPr>
            </p:pic>
            <p:pic>
              <p:nvPicPr>
                <p:cNvPr id="240" name="Content Placeholder 3">
                  <a:extLst>
                    <a:ext uri="{FF2B5EF4-FFF2-40B4-BE49-F238E27FC236}">
                      <a16:creationId xmlns:a16="http://schemas.microsoft.com/office/drawing/2014/main" id="{B8B5C42F-FDE0-4FB3-A039-BE005B92D7A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/>
                <a:srcRect l="4469" t="16807" r="7972" b="6336"/>
                <a:stretch/>
              </p:blipFill>
              <p:spPr>
                <a:xfrm>
                  <a:off x="2634694" y="4630119"/>
                  <a:ext cx="1979273" cy="1737360"/>
                </a:xfrm>
                <a:prstGeom prst="rect">
                  <a:avLst/>
                </a:prstGeom>
              </p:spPr>
            </p:pic>
            <p:pic>
              <p:nvPicPr>
                <p:cNvPr id="241" name="Content Placeholder 3">
                  <a:extLst>
                    <a:ext uri="{FF2B5EF4-FFF2-40B4-BE49-F238E27FC236}">
                      <a16:creationId xmlns:a16="http://schemas.microsoft.com/office/drawing/2014/main" id="{065E796C-F9D0-42B4-86B6-8854DEF2A27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/>
                <a:srcRect l="4664" t="17195" r="6025" b="6142"/>
                <a:stretch/>
              </p:blipFill>
              <p:spPr>
                <a:xfrm>
                  <a:off x="4732654" y="4641798"/>
                  <a:ext cx="2023985" cy="1737360"/>
                </a:xfrm>
                <a:prstGeom prst="rect">
                  <a:avLst/>
                </a:prstGeom>
              </p:spPr>
            </p:pic>
            <p:grpSp>
              <p:nvGrpSpPr>
                <p:cNvPr id="242" name="Group 241">
                  <a:extLst>
                    <a:ext uri="{FF2B5EF4-FFF2-40B4-BE49-F238E27FC236}">
                      <a16:creationId xmlns:a16="http://schemas.microsoft.com/office/drawing/2014/main" id="{7A8F63D1-124F-4712-8B3E-26EDD432B59D}"/>
                    </a:ext>
                  </a:extLst>
                </p:cNvPr>
                <p:cNvGrpSpPr/>
                <p:nvPr/>
              </p:nvGrpSpPr>
              <p:grpSpPr>
                <a:xfrm>
                  <a:off x="174804" y="4453049"/>
                  <a:ext cx="6658069" cy="2033593"/>
                  <a:chOff x="113414" y="2425758"/>
                  <a:chExt cx="6658069" cy="2033593"/>
                </a:xfrm>
              </p:grpSpPr>
              <p:grpSp>
                <p:nvGrpSpPr>
                  <p:cNvPr id="243" name="Group 242">
                    <a:extLst>
                      <a:ext uri="{FF2B5EF4-FFF2-40B4-BE49-F238E27FC236}">
                        <a16:creationId xmlns:a16="http://schemas.microsoft.com/office/drawing/2014/main" id="{D35285D9-D0DA-4072-826D-6E1BA8835FF0}"/>
                      </a:ext>
                    </a:extLst>
                  </p:cNvPr>
                  <p:cNvGrpSpPr/>
                  <p:nvPr/>
                </p:nvGrpSpPr>
                <p:grpSpPr>
                  <a:xfrm>
                    <a:off x="334843" y="2425758"/>
                    <a:ext cx="4881256" cy="253916"/>
                    <a:chOff x="1884133" y="116423"/>
                    <a:chExt cx="4881256" cy="253916"/>
                  </a:xfrm>
                </p:grpSpPr>
                <p:sp>
                  <p:nvSpPr>
                    <p:cNvPr id="257" name="TextBox 256">
                      <a:extLst>
                        <a:ext uri="{FF2B5EF4-FFF2-40B4-BE49-F238E27FC236}">
                          <a16:creationId xmlns:a16="http://schemas.microsoft.com/office/drawing/2014/main" id="{6935268B-D117-4A7F-9280-2ABF9F4F248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136635" y="116423"/>
                      <a:ext cx="352836" cy="2539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</a:p>
                  </p:txBody>
                </p:sp>
                <p:sp>
                  <p:nvSpPr>
                    <p:cNvPr id="258" name="TextBox 257">
                      <a:extLst>
                        <a:ext uri="{FF2B5EF4-FFF2-40B4-BE49-F238E27FC236}">
                          <a16:creationId xmlns:a16="http://schemas.microsoft.com/office/drawing/2014/main" id="{7796977E-7595-4CD3-A1F9-FA3323CEDE0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84133" y="116423"/>
                      <a:ext cx="400142" cy="2539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p:txBody>
                </p:sp>
                <p:sp>
                  <p:nvSpPr>
                    <p:cNvPr id="259" name="TextBox 258">
                      <a:extLst>
                        <a:ext uri="{FF2B5EF4-FFF2-40B4-BE49-F238E27FC236}">
                          <a16:creationId xmlns:a16="http://schemas.microsoft.com/office/drawing/2014/main" id="{43FD77D1-D7FD-43A1-BDA4-3CAFEDDE4E4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341830" y="116423"/>
                      <a:ext cx="423559" cy="2539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</p:txBody>
                </p:sp>
              </p:grpSp>
              <p:grpSp>
                <p:nvGrpSpPr>
                  <p:cNvPr id="244" name="Group 243">
                    <a:extLst>
                      <a:ext uri="{FF2B5EF4-FFF2-40B4-BE49-F238E27FC236}">
                        <a16:creationId xmlns:a16="http://schemas.microsoft.com/office/drawing/2014/main" id="{8CF84AF7-CEAF-4F27-8602-810C0638709E}"/>
                      </a:ext>
                    </a:extLst>
                  </p:cNvPr>
                  <p:cNvGrpSpPr/>
                  <p:nvPr/>
                </p:nvGrpSpPr>
                <p:grpSpPr>
                  <a:xfrm>
                    <a:off x="113414" y="2553541"/>
                    <a:ext cx="6658069" cy="1905810"/>
                    <a:chOff x="113414" y="2553541"/>
                    <a:chExt cx="6658069" cy="1905810"/>
                  </a:xfrm>
                </p:grpSpPr>
                <p:grpSp>
                  <p:nvGrpSpPr>
                    <p:cNvPr id="245" name="Group 244">
                      <a:extLst>
                        <a:ext uri="{FF2B5EF4-FFF2-40B4-BE49-F238E27FC236}">
                          <a16:creationId xmlns:a16="http://schemas.microsoft.com/office/drawing/2014/main" id="{E31062AB-7571-4B86-AF98-A77CD21EE60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13414" y="2611924"/>
                      <a:ext cx="2217822" cy="1843693"/>
                      <a:chOff x="109021" y="129620"/>
                      <a:chExt cx="2217822" cy="1843693"/>
                    </a:xfrm>
                  </p:grpSpPr>
                  <p:sp>
                    <p:nvSpPr>
                      <p:cNvPr id="254" name="TextBox 253">
                        <a:extLst>
                          <a:ext uri="{FF2B5EF4-FFF2-40B4-BE49-F238E27FC236}">
                            <a16:creationId xmlns:a16="http://schemas.microsoft.com/office/drawing/2014/main" id="{5D56B208-9A24-481C-9CFD-449EA87EE3AF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800000">
                        <a:off x="290719" y="1726381"/>
                        <a:ext cx="950291" cy="2469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 (mg kg</a:t>
                        </a:r>
                        <a:r>
                          <a:rPr lang="en-US" sz="1000" baseline="300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ea typeface="Times New Roman" panose="02020603050405020304" pitchFamily="18" charset="0"/>
                            <a:cs typeface="Arial" panose="020B0604020202020204" pitchFamily="34" charset="0"/>
                          </a:rPr>
                          <a:t>‒1</a:t>
                        </a:r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)</a:t>
                        </a:r>
                        <a:endParaRPr 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55" name="TextBox 254">
                        <a:extLst>
                          <a:ext uri="{FF2B5EF4-FFF2-40B4-BE49-F238E27FC236}">
                            <a16:creationId xmlns:a16="http://schemas.microsoft.com/office/drawing/2014/main" id="{368ADA04-25F9-4210-85D9-FF78F09570B3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920000">
                        <a:off x="1484396" y="1673099"/>
                        <a:ext cx="842447" cy="2469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N (mg kg</a:t>
                        </a:r>
                        <a:r>
                          <a:rPr lang="en-US" sz="1000" baseline="300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ea typeface="Times New Roman" panose="02020603050405020304" pitchFamily="18" charset="0"/>
                            <a:cs typeface="Arial" panose="020B0604020202020204" pitchFamily="34" charset="0"/>
                          </a:rPr>
                          <a:t>‒1</a:t>
                        </a:r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)</a:t>
                        </a:r>
                        <a:endParaRPr 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56" name="TextBox 255">
                        <a:extLst>
                          <a:ext uri="{FF2B5EF4-FFF2-40B4-BE49-F238E27FC236}">
                            <a16:creationId xmlns:a16="http://schemas.microsoft.com/office/drawing/2014/main" id="{856E11AB-BC91-42AC-BD05-94786B9B1B01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080000">
                        <a:off x="-528111" y="766752"/>
                        <a:ext cx="1520486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Dry biomass (g plant</a:t>
                        </a:r>
                        <a:r>
                          <a:rPr lang="en-US" sz="1000" baseline="300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ea typeface="Times New Roman" panose="02020603050405020304" pitchFamily="18" charset="0"/>
                            <a:cs typeface="Arial" panose="020B0604020202020204" pitchFamily="34" charset="0"/>
                          </a:rPr>
                          <a:t>‒1</a:t>
                        </a:r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)</a:t>
                        </a:r>
                        <a:endParaRPr 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246" name="Group 245">
                      <a:extLst>
                        <a:ext uri="{FF2B5EF4-FFF2-40B4-BE49-F238E27FC236}">
                          <a16:creationId xmlns:a16="http://schemas.microsoft.com/office/drawing/2014/main" id="{6E759833-47FD-4D81-AF70-34A2B586A3E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335391" y="2553541"/>
                      <a:ext cx="2261779" cy="1905810"/>
                      <a:chOff x="2144118" y="48770"/>
                      <a:chExt cx="2261779" cy="1905810"/>
                    </a:xfrm>
                  </p:grpSpPr>
                  <p:sp>
                    <p:nvSpPr>
                      <p:cNvPr id="251" name="TextBox 250">
                        <a:extLst>
                          <a:ext uri="{FF2B5EF4-FFF2-40B4-BE49-F238E27FC236}">
                            <a16:creationId xmlns:a16="http://schemas.microsoft.com/office/drawing/2014/main" id="{30129CEC-0969-4820-B0D9-05A4350417A0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080000">
                        <a:off x="1506431" y="686457"/>
                        <a:ext cx="1521596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/S ratio</a:t>
                        </a:r>
                        <a:endParaRPr 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52" name="TextBox 251">
                        <a:extLst>
                          <a:ext uri="{FF2B5EF4-FFF2-40B4-BE49-F238E27FC236}">
                            <a16:creationId xmlns:a16="http://schemas.microsoft.com/office/drawing/2014/main" id="{5A10A569-8B73-496A-9091-F0FF33B07BA8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">
                        <a:off x="2395834" y="1708359"/>
                        <a:ext cx="920946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N (mg kg</a:t>
                        </a:r>
                        <a:r>
                          <a:rPr lang="en-US" sz="1000" baseline="300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ea typeface="Times New Roman" panose="02020603050405020304" pitchFamily="18" charset="0"/>
                            <a:cs typeface="Arial" panose="020B0604020202020204" pitchFamily="34" charset="0"/>
                          </a:rPr>
                          <a:t>‒1</a:t>
                        </a:r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)</a:t>
                        </a:r>
                        <a:endParaRPr 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53" name="TextBox 252">
                        <a:extLst>
                          <a:ext uri="{FF2B5EF4-FFF2-40B4-BE49-F238E27FC236}">
                            <a16:creationId xmlns:a16="http://schemas.microsoft.com/office/drawing/2014/main" id="{AD8DDABF-B6D7-4AE7-8430-5CEBE8BD9AF2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920000">
                        <a:off x="3563450" y="1643692"/>
                        <a:ext cx="842447" cy="2469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W (% FC)</a:t>
                        </a:r>
                        <a:endParaRPr 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247" name="Group 246">
                      <a:extLst>
                        <a:ext uri="{FF2B5EF4-FFF2-40B4-BE49-F238E27FC236}">
                          <a16:creationId xmlns:a16="http://schemas.microsoft.com/office/drawing/2014/main" id="{F4D03FBE-CE56-4F0F-B990-E3FEF389A4C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463459" y="2634045"/>
                      <a:ext cx="2308024" cy="1775522"/>
                      <a:chOff x="4347290" y="247671"/>
                      <a:chExt cx="2308024" cy="1775522"/>
                    </a:xfrm>
                  </p:grpSpPr>
                  <p:sp>
                    <p:nvSpPr>
                      <p:cNvPr id="248" name="TextBox 247">
                        <a:extLst>
                          <a:ext uri="{FF2B5EF4-FFF2-40B4-BE49-F238E27FC236}">
                            <a16:creationId xmlns:a16="http://schemas.microsoft.com/office/drawing/2014/main" id="{F91213D6-1E3C-4E96-92C5-68CA48CEC042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">
                        <a:off x="4567235" y="1776972"/>
                        <a:ext cx="920946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 (mg kg</a:t>
                        </a:r>
                        <a:r>
                          <a:rPr lang="en-US" sz="1000" baseline="300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ea typeface="Times New Roman" panose="02020603050405020304" pitchFamily="18" charset="0"/>
                            <a:cs typeface="Arial" panose="020B0604020202020204" pitchFamily="34" charset="0"/>
                          </a:rPr>
                          <a:t>‒1</a:t>
                        </a:r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)</a:t>
                        </a:r>
                        <a:endParaRPr 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49" name="TextBox 248">
                        <a:extLst>
                          <a:ext uri="{FF2B5EF4-FFF2-40B4-BE49-F238E27FC236}">
                            <a16:creationId xmlns:a16="http://schemas.microsoft.com/office/drawing/2014/main" id="{5AB53FBE-4D00-4E04-B3C5-F5DD4D9AF8E8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080000">
                        <a:off x="3825835" y="769126"/>
                        <a:ext cx="1289131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/S ratio</a:t>
                        </a:r>
                        <a:endParaRPr 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50" name="TextBox 249">
                        <a:extLst>
                          <a:ext uri="{FF2B5EF4-FFF2-40B4-BE49-F238E27FC236}">
                            <a16:creationId xmlns:a16="http://schemas.microsoft.com/office/drawing/2014/main" id="{F3022556-4321-44DC-B1B3-FACFC327C910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800000">
                        <a:off x="5705023" y="1746827"/>
                        <a:ext cx="950291" cy="2469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N (mg kg</a:t>
                        </a:r>
                        <a:r>
                          <a:rPr lang="en-US" sz="1000" baseline="300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ea typeface="Times New Roman" panose="02020603050405020304" pitchFamily="18" charset="0"/>
                            <a:cs typeface="Arial" panose="020B0604020202020204" pitchFamily="34" charset="0"/>
                          </a:rPr>
                          <a:t>‒1</a:t>
                        </a:r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)</a:t>
                        </a:r>
                        <a:endParaRPr 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</p:grpSp>
            </p:grpSp>
          </p:grpSp>
        </p:grpSp>
        <p:grpSp>
          <p:nvGrpSpPr>
            <p:cNvPr id="215" name="Group 214">
              <a:extLst>
                <a:ext uri="{FF2B5EF4-FFF2-40B4-BE49-F238E27FC236}">
                  <a16:creationId xmlns:a16="http://schemas.microsoft.com/office/drawing/2014/main" id="{B5892477-9A07-4DAB-ACD4-2BFD70DFAA4E}"/>
                </a:ext>
              </a:extLst>
            </p:cNvPr>
            <p:cNvGrpSpPr/>
            <p:nvPr/>
          </p:nvGrpSpPr>
          <p:grpSpPr>
            <a:xfrm>
              <a:off x="97979" y="246316"/>
              <a:ext cx="6662041" cy="2033593"/>
              <a:chOff x="97979" y="246316"/>
              <a:chExt cx="6662041" cy="2033593"/>
            </a:xfrm>
          </p:grpSpPr>
          <p:pic>
            <p:nvPicPr>
              <p:cNvPr id="216" name="Content Placeholder 3">
                <a:extLst>
                  <a:ext uri="{FF2B5EF4-FFF2-40B4-BE49-F238E27FC236}">
                    <a16:creationId xmlns:a16="http://schemas.microsoft.com/office/drawing/2014/main" id="{7620D93B-E08F-4B37-B547-FEA473D8E3D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3691" t="16612" r="7972" b="5363"/>
              <a:stretch/>
            </p:blipFill>
            <p:spPr>
              <a:xfrm>
                <a:off x="330324" y="450699"/>
                <a:ext cx="1966985" cy="1737360"/>
              </a:xfrm>
              <a:prstGeom prst="rect">
                <a:avLst/>
              </a:prstGeom>
            </p:spPr>
          </p:pic>
          <p:grpSp>
            <p:nvGrpSpPr>
              <p:cNvPr id="217" name="Group 216">
                <a:extLst>
                  <a:ext uri="{FF2B5EF4-FFF2-40B4-BE49-F238E27FC236}">
                    <a16:creationId xmlns:a16="http://schemas.microsoft.com/office/drawing/2014/main" id="{896E153E-4729-4B99-94BC-862A25DC7359}"/>
                  </a:ext>
                </a:extLst>
              </p:cNvPr>
              <p:cNvGrpSpPr/>
              <p:nvPr/>
            </p:nvGrpSpPr>
            <p:grpSpPr>
              <a:xfrm>
                <a:off x="97979" y="246316"/>
                <a:ext cx="6662041" cy="2033593"/>
                <a:chOff x="97979" y="246316"/>
                <a:chExt cx="6662041" cy="2033593"/>
              </a:xfrm>
            </p:grpSpPr>
            <p:pic>
              <p:nvPicPr>
                <p:cNvPr id="218" name="Content Placeholder 3">
                  <a:extLst>
                    <a:ext uri="{FF2B5EF4-FFF2-40B4-BE49-F238E27FC236}">
                      <a16:creationId xmlns:a16="http://schemas.microsoft.com/office/drawing/2014/main" id="{6F7E8988-03A3-425E-95E6-736BA78D6AB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/>
                <a:srcRect l="3886" t="16807" r="5831" b="6141"/>
                <a:stretch/>
              </p:blipFill>
              <p:spPr>
                <a:xfrm>
                  <a:off x="2471230" y="428647"/>
                  <a:ext cx="2035691" cy="1737360"/>
                </a:xfrm>
                <a:prstGeom prst="rect">
                  <a:avLst/>
                </a:prstGeom>
              </p:spPr>
            </p:pic>
            <p:pic>
              <p:nvPicPr>
                <p:cNvPr id="219" name="Content Placeholder 3">
                  <a:extLst>
                    <a:ext uri="{FF2B5EF4-FFF2-40B4-BE49-F238E27FC236}">
                      <a16:creationId xmlns:a16="http://schemas.microsoft.com/office/drawing/2014/main" id="{CB28FE7C-7D82-45D1-A248-8E9082CDE49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/>
                <a:srcRect l="5782" t="16417" r="8117" b="5655"/>
                <a:stretch/>
              </p:blipFill>
              <p:spPr>
                <a:xfrm>
                  <a:off x="4717323" y="402530"/>
                  <a:ext cx="1919558" cy="1737360"/>
                </a:xfrm>
                <a:prstGeom prst="rect">
                  <a:avLst/>
                </a:prstGeom>
              </p:spPr>
            </p:pic>
            <p:grpSp>
              <p:nvGrpSpPr>
                <p:cNvPr id="220" name="Group 219">
                  <a:extLst>
                    <a:ext uri="{FF2B5EF4-FFF2-40B4-BE49-F238E27FC236}">
                      <a16:creationId xmlns:a16="http://schemas.microsoft.com/office/drawing/2014/main" id="{F9F0C54A-EAB4-4EC2-8415-BEA29D5D5F86}"/>
                    </a:ext>
                  </a:extLst>
                </p:cNvPr>
                <p:cNvGrpSpPr/>
                <p:nvPr/>
              </p:nvGrpSpPr>
              <p:grpSpPr>
                <a:xfrm>
                  <a:off x="97979" y="246316"/>
                  <a:ext cx="6662041" cy="2033593"/>
                  <a:chOff x="97979" y="246316"/>
                  <a:chExt cx="6662041" cy="2033593"/>
                </a:xfrm>
              </p:grpSpPr>
              <p:grpSp>
                <p:nvGrpSpPr>
                  <p:cNvPr id="221" name="Group 220">
                    <a:extLst>
                      <a:ext uri="{FF2B5EF4-FFF2-40B4-BE49-F238E27FC236}">
                        <a16:creationId xmlns:a16="http://schemas.microsoft.com/office/drawing/2014/main" id="{8791B399-267B-42F9-84EB-FDA148829A15}"/>
                      </a:ext>
                    </a:extLst>
                  </p:cNvPr>
                  <p:cNvGrpSpPr/>
                  <p:nvPr/>
                </p:nvGrpSpPr>
                <p:grpSpPr>
                  <a:xfrm>
                    <a:off x="323380" y="246316"/>
                    <a:ext cx="4881256" cy="253916"/>
                    <a:chOff x="1884133" y="116423"/>
                    <a:chExt cx="4881256" cy="253916"/>
                  </a:xfrm>
                </p:grpSpPr>
                <p:sp>
                  <p:nvSpPr>
                    <p:cNvPr id="234" name="TextBox 233">
                      <a:extLst>
                        <a:ext uri="{FF2B5EF4-FFF2-40B4-BE49-F238E27FC236}">
                          <a16:creationId xmlns:a16="http://schemas.microsoft.com/office/drawing/2014/main" id="{15EDFBF0-D05A-4063-AA2E-81DB3081187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136635" y="116423"/>
                      <a:ext cx="352836" cy="2539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</a:p>
                  </p:txBody>
                </p:sp>
                <p:sp>
                  <p:nvSpPr>
                    <p:cNvPr id="235" name="TextBox 234">
                      <a:extLst>
                        <a:ext uri="{FF2B5EF4-FFF2-40B4-BE49-F238E27FC236}">
                          <a16:creationId xmlns:a16="http://schemas.microsoft.com/office/drawing/2014/main" id="{CEE23EC7-A928-4B83-A661-7E2FD90AD6B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84133" y="116423"/>
                      <a:ext cx="400142" cy="2539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p:txBody>
                </p:sp>
                <p:sp>
                  <p:nvSpPr>
                    <p:cNvPr id="236" name="TextBox 235">
                      <a:extLst>
                        <a:ext uri="{FF2B5EF4-FFF2-40B4-BE49-F238E27FC236}">
                          <a16:creationId xmlns:a16="http://schemas.microsoft.com/office/drawing/2014/main" id="{466CE2A8-18CD-40EA-9F69-D6D7AA65180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341830" y="116423"/>
                      <a:ext cx="423559" cy="2539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p:txBody>
                </p:sp>
              </p:grpSp>
              <p:grpSp>
                <p:nvGrpSpPr>
                  <p:cNvPr id="222" name="Group 221">
                    <a:extLst>
                      <a:ext uri="{FF2B5EF4-FFF2-40B4-BE49-F238E27FC236}">
                        <a16:creationId xmlns:a16="http://schemas.microsoft.com/office/drawing/2014/main" id="{C0CDAC04-0E39-4ECC-B33F-D86B9DB894B4}"/>
                      </a:ext>
                    </a:extLst>
                  </p:cNvPr>
                  <p:cNvGrpSpPr/>
                  <p:nvPr/>
                </p:nvGrpSpPr>
                <p:grpSpPr>
                  <a:xfrm>
                    <a:off x="97979" y="432551"/>
                    <a:ext cx="2221794" cy="1843624"/>
                    <a:chOff x="105049" y="129689"/>
                    <a:chExt cx="2221794" cy="1843624"/>
                  </a:xfrm>
                </p:grpSpPr>
                <p:sp>
                  <p:nvSpPr>
                    <p:cNvPr id="231" name="TextBox 230">
                      <a:extLst>
                        <a:ext uri="{FF2B5EF4-FFF2-40B4-BE49-F238E27FC236}">
                          <a16:creationId xmlns:a16="http://schemas.microsoft.com/office/drawing/2014/main" id="{7B573C43-CA05-4091-A909-856612B9D2C6}"/>
                        </a:ext>
                      </a:extLst>
                    </p:cNvPr>
                    <p:cNvSpPr txBox="1"/>
                    <p:nvPr/>
                  </p:nvSpPr>
                  <p:spPr>
                    <a:xfrm rot="1800000">
                      <a:off x="290719" y="1726381"/>
                      <a:ext cx="950291" cy="2469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(mg kg</a:t>
                      </a:r>
                      <a:r>
                        <a:rPr lang="en-US" sz="100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‒1</a:t>
                      </a: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32" name="TextBox 231">
                      <a:extLst>
                        <a:ext uri="{FF2B5EF4-FFF2-40B4-BE49-F238E27FC236}">
                          <a16:creationId xmlns:a16="http://schemas.microsoft.com/office/drawing/2014/main" id="{43DC95B9-0B4A-4484-B5D6-39BB03F51B23}"/>
                        </a:ext>
                      </a:extLst>
                    </p:cNvPr>
                    <p:cNvSpPr txBox="1"/>
                    <p:nvPr/>
                  </p:nvSpPr>
                  <p:spPr>
                    <a:xfrm rot="19920000">
                      <a:off x="1484396" y="1673099"/>
                      <a:ext cx="842447" cy="2469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 (% FC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33" name="TextBox 232">
                      <a:extLst>
                        <a:ext uri="{FF2B5EF4-FFF2-40B4-BE49-F238E27FC236}">
                          <a16:creationId xmlns:a16="http://schemas.microsoft.com/office/drawing/2014/main" id="{8B50713B-45DD-4616-A68F-65215E0D34D1}"/>
                        </a:ext>
                      </a:extLst>
                    </p:cNvPr>
                    <p:cNvSpPr txBox="1"/>
                    <p:nvPr/>
                  </p:nvSpPr>
                  <p:spPr>
                    <a:xfrm rot="16080000">
                      <a:off x="-418266" y="653004"/>
                      <a:ext cx="129285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 height (cm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223" name="Group 222">
                    <a:extLst>
                      <a:ext uri="{FF2B5EF4-FFF2-40B4-BE49-F238E27FC236}">
                        <a16:creationId xmlns:a16="http://schemas.microsoft.com/office/drawing/2014/main" id="{A7A7AA56-7E97-4845-BFC0-AB891355DBA8}"/>
                      </a:ext>
                    </a:extLst>
                  </p:cNvPr>
                  <p:cNvGrpSpPr/>
                  <p:nvPr/>
                </p:nvGrpSpPr>
                <p:grpSpPr>
                  <a:xfrm>
                    <a:off x="2278335" y="374473"/>
                    <a:ext cx="2231172" cy="1905436"/>
                    <a:chOff x="2174725" y="49144"/>
                    <a:chExt cx="2231172" cy="1905436"/>
                  </a:xfrm>
                </p:grpSpPr>
                <p:sp>
                  <p:nvSpPr>
                    <p:cNvPr id="228" name="TextBox 227">
                      <a:extLst>
                        <a:ext uri="{FF2B5EF4-FFF2-40B4-BE49-F238E27FC236}">
                          <a16:creationId xmlns:a16="http://schemas.microsoft.com/office/drawing/2014/main" id="{910C1DBA-4329-49A3-9114-1F0BA6C19894}"/>
                        </a:ext>
                      </a:extLst>
                    </p:cNvPr>
                    <p:cNvSpPr txBox="1"/>
                    <p:nvPr/>
                  </p:nvSpPr>
                  <p:spPr>
                    <a:xfrm rot="16080000">
                      <a:off x="1607446" y="616423"/>
                      <a:ext cx="138078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 height (cm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29" name="TextBox 228">
                      <a:extLst>
                        <a:ext uri="{FF2B5EF4-FFF2-40B4-BE49-F238E27FC236}">
                          <a16:creationId xmlns:a16="http://schemas.microsoft.com/office/drawing/2014/main" id="{3E997042-0BB6-4048-A340-5D8752F11AF4}"/>
                        </a:ext>
                      </a:extLst>
                    </p:cNvPr>
                    <p:cNvSpPr txBox="1"/>
                    <p:nvPr/>
                  </p:nvSpPr>
                  <p:spPr>
                    <a:xfrm rot="1620000">
                      <a:off x="2395834" y="1708359"/>
                      <a:ext cx="920946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(mg kg</a:t>
                      </a:r>
                      <a:r>
                        <a:rPr lang="en-US" sz="100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‒1</a:t>
                      </a: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30" name="TextBox 229">
                      <a:extLst>
                        <a:ext uri="{FF2B5EF4-FFF2-40B4-BE49-F238E27FC236}">
                          <a16:creationId xmlns:a16="http://schemas.microsoft.com/office/drawing/2014/main" id="{4D3D25B8-1F5E-4178-9CEA-3E8E6F64FE30}"/>
                        </a:ext>
                      </a:extLst>
                    </p:cNvPr>
                    <p:cNvSpPr txBox="1"/>
                    <p:nvPr/>
                  </p:nvSpPr>
                  <p:spPr>
                    <a:xfrm rot="19920000">
                      <a:off x="3563450" y="1643692"/>
                      <a:ext cx="842447" cy="2469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(mg kg</a:t>
                      </a:r>
                      <a:r>
                        <a:rPr lang="en-US" sz="100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‒1</a:t>
                      </a: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224" name="Group 223">
                    <a:extLst>
                      <a:ext uri="{FF2B5EF4-FFF2-40B4-BE49-F238E27FC236}">
                        <a16:creationId xmlns:a16="http://schemas.microsoft.com/office/drawing/2014/main" id="{F554FEA2-2D81-4912-B532-7DFADACE9E9E}"/>
                      </a:ext>
                    </a:extLst>
                  </p:cNvPr>
                  <p:cNvGrpSpPr/>
                  <p:nvPr/>
                </p:nvGrpSpPr>
                <p:grpSpPr>
                  <a:xfrm>
                    <a:off x="4453610" y="454575"/>
                    <a:ext cx="2306410" cy="1775550"/>
                    <a:chOff x="4348904" y="247643"/>
                    <a:chExt cx="2306410" cy="1775550"/>
                  </a:xfrm>
                </p:grpSpPr>
                <p:sp>
                  <p:nvSpPr>
                    <p:cNvPr id="225" name="TextBox 224">
                      <a:extLst>
                        <a:ext uri="{FF2B5EF4-FFF2-40B4-BE49-F238E27FC236}">
                          <a16:creationId xmlns:a16="http://schemas.microsoft.com/office/drawing/2014/main" id="{236458F3-6A1E-4449-913F-EC93127DCDEE}"/>
                        </a:ext>
                      </a:extLst>
                    </p:cNvPr>
                    <p:cNvSpPr txBox="1"/>
                    <p:nvPr/>
                  </p:nvSpPr>
                  <p:spPr>
                    <a:xfrm rot="1620000">
                      <a:off x="4567235" y="1776972"/>
                      <a:ext cx="920946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(mg kg</a:t>
                      </a:r>
                      <a:r>
                        <a:rPr lang="en-US" sz="100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‒1</a:t>
                      </a: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26" name="TextBox 225">
                      <a:extLst>
                        <a:ext uri="{FF2B5EF4-FFF2-40B4-BE49-F238E27FC236}">
                          <a16:creationId xmlns:a16="http://schemas.microsoft.com/office/drawing/2014/main" id="{D915ED9F-51DA-424E-9736-3409541D2A65}"/>
                        </a:ext>
                      </a:extLst>
                    </p:cNvPr>
                    <p:cNvSpPr txBox="1"/>
                    <p:nvPr/>
                  </p:nvSpPr>
                  <p:spPr>
                    <a:xfrm rot="16080000">
                      <a:off x="3781148" y="815399"/>
                      <a:ext cx="1381733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m diameter (mm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27" name="TextBox 226">
                      <a:extLst>
                        <a:ext uri="{FF2B5EF4-FFF2-40B4-BE49-F238E27FC236}">
                          <a16:creationId xmlns:a16="http://schemas.microsoft.com/office/drawing/2014/main" id="{4B68D61E-D498-4636-A47D-218F735667BA}"/>
                        </a:ext>
                      </a:extLst>
                    </p:cNvPr>
                    <p:cNvSpPr txBox="1"/>
                    <p:nvPr/>
                  </p:nvSpPr>
                  <p:spPr>
                    <a:xfrm rot="19800000">
                      <a:off x="5705023" y="1746827"/>
                      <a:ext cx="950291" cy="2469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 (% FC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</p:grpSp>
        </p:grpSp>
      </p:grpSp>
    </p:spTree>
    <p:extLst>
      <p:ext uri="{BB962C8B-B14F-4D97-AF65-F5344CB8AC3E}">
        <p14:creationId xmlns:p14="http://schemas.microsoft.com/office/powerpoint/2010/main" val="28074897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6</TotalTime>
  <Words>169</Words>
  <Application>Microsoft Office PowerPoint</Application>
  <PresentationFormat>A4 Paper (210x297 mm)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Rana Roy</cp:lastModifiedBy>
  <cp:revision>139</cp:revision>
  <dcterms:created xsi:type="dcterms:W3CDTF">2017-06-07T09:14:07Z</dcterms:created>
  <dcterms:modified xsi:type="dcterms:W3CDTF">2020-04-10T04:13:24Z</dcterms:modified>
</cp:coreProperties>
</file>